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30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3">
            <a:extLst>
              <a:ext uri="{FF2B5EF4-FFF2-40B4-BE49-F238E27FC236}">
                <a16:creationId xmlns:a16="http://schemas.microsoft.com/office/drawing/2014/main" id="{FD42A9C5-082F-E94B-98F9-4E780F2CF7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5956" y="639612"/>
            <a:ext cx="4265154" cy="512256"/>
          </a:xfrm>
        </p:spPr>
        <p:txBody>
          <a:bodyPr>
            <a:noAutofit/>
          </a:bodyPr>
          <a:lstStyle/>
          <a:p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Supplemental Table S3: Patient demographics in 1</a:t>
            </a:r>
            <a:r>
              <a:rPr lang="en-US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 Line Cohort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A0D0167-1608-0346-BCFA-0ADBE8310CD9}"/>
              </a:ext>
            </a:extLst>
          </p:cNvPr>
          <p:cNvGraphicFramePr>
            <a:graphicFrameLocks noGrp="1"/>
          </p:cNvGraphicFramePr>
          <p:nvPr/>
        </p:nvGraphicFramePr>
        <p:xfrm>
          <a:off x="7550891" y="260897"/>
          <a:ext cx="4052532" cy="6056128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425332">
                  <a:extLst>
                    <a:ext uri="{9D8B030D-6E8A-4147-A177-3AD203B41FA5}">
                      <a16:colId xmlns:a16="http://schemas.microsoft.com/office/drawing/2014/main" val="2966675807"/>
                    </a:ext>
                  </a:extLst>
                </a:gridCol>
                <a:gridCol w="700587">
                  <a:extLst>
                    <a:ext uri="{9D8B030D-6E8A-4147-A177-3AD203B41FA5}">
                      <a16:colId xmlns:a16="http://schemas.microsoft.com/office/drawing/2014/main" val="3146431282"/>
                    </a:ext>
                  </a:extLst>
                </a:gridCol>
                <a:gridCol w="700587">
                  <a:extLst>
                    <a:ext uri="{9D8B030D-6E8A-4147-A177-3AD203B41FA5}">
                      <a16:colId xmlns:a16="http://schemas.microsoft.com/office/drawing/2014/main" val="4117141256"/>
                    </a:ext>
                  </a:extLst>
                </a:gridCol>
                <a:gridCol w="700587">
                  <a:extLst>
                    <a:ext uri="{9D8B030D-6E8A-4147-A177-3AD203B41FA5}">
                      <a16:colId xmlns:a16="http://schemas.microsoft.com/office/drawing/2014/main" val="2134273691"/>
                    </a:ext>
                  </a:extLst>
                </a:gridCol>
                <a:gridCol w="525439">
                  <a:extLst>
                    <a:ext uri="{9D8B030D-6E8A-4147-A177-3AD203B41FA5}">
                      <a16:colId xmlns:a16="http://schemas.microsoft.com/office/drawing/2014/main" val="3048539195"/>
                    </a:ext>
                  </a:extLst>
                </a:gridCol>
              </a:tblGrid>
              <a:tr h="67990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Chemo (N=659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ICPI (N=3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Total (N=692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p valu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92297585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Age at Dx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0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68958937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edian (Q1, Q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6.0 (57.0, 72.0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0.0 (59.0, 75.0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6.0 (57.0, 73.0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23756203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ex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7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00126996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0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 (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0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009627710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F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64 (24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 (30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4 (25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648896907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94 (75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 (69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17 (74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929515835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Rac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08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64732681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frican America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 (3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 (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 (3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232845096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European America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30 (65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 (51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47 (64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55626535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Other or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07 (31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6 (48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3 (32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862236746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actice Typ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3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798082335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cademi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2 (7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3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3 (7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051566426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ommunity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07 (92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2 (97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39 (92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357738406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ite of Primary Tumo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078092243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Esophage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7 (37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 (30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57 (37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11988776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Gastri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0 (34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5 (45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45 (35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878168587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Gastroesophageal Junction (GEJ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2 (27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8 (24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90 (27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344804215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tage at Dx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&lt; 0.0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145421203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 (1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3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2 (1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35565057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9 (9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 (15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4 (9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59663235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I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0 (15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 (33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1 (16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04917679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Stage IV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38 (66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 (27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47 (64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849495860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/not documente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1 (7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 (21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8 (8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713197379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History of Smokin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19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19248064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History of smokin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21 (63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6 (48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37 (63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728306174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 history of smokin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7 (36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7 (51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54 (36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602930899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/Not documente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0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 (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0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528286797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or Surgery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&lt; 0.0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8998469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27 (8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 (30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37 (77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740281923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Ye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2 (2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 (69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55 (22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47786183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CO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0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76664155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28 (39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 (12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32 (37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45145464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61 (44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8 (56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79 (45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11257267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3+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5 (16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 (31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5 (17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24531467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830956279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HER2 IH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6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27716080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egativ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38 (81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5 (75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63 (81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128390777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Positiv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5 (2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 (3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6 (2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293957529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6 (16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 (21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3 (16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895350055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TM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3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09486097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edian (Q1, Q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.8 (1.7, 6.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.8 (2.5, 8.8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.8 (1.7, 6.3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64675966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MSI by NG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8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2652930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SI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5 (20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 (18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41 (20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612472364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SI-H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0 (4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 (6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2 (4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17506360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S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94 (75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5 (75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19 (75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636909549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D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&lt; 0.0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116647440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2 (10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 (6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4 (10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04742544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1-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6 (14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 (21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03 (14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87954787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10+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99 (15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4 (42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13 (16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64795159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CPS 5-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7 (8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 (9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0 (8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90351114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unknow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35 (50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7 (21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42 (49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248483506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Album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0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140083944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Below LL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43 (23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3 (40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56 (24.7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4232839759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rm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57 (76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9 (59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76 (75.3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420559666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29566658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ilirub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819581719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bove UL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6 (6.1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 (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6 (5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665683688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rm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55 (93.9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2 (100.0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87 (94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388325742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6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694215583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0.7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02184452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Above UL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6 (7.6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2 (6.2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48 (7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341012490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Norm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62 (92.4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30 (93.8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92 (92.5%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2830116981"/>
                  </a:ext>
                </a:extLst>
              </a:tr>
              <a:tr h="6799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  Missing Observation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u="none" strike="noStrike">
                          <a:effectLst/>
                        </a:rPr>
                        <a:t>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87" marR="3187" marT="3187" marB="0" anchor="b"/>
                </a:tc>
                <a:extLst>
                  <a:ext uri="{0D108BD9-81ED-4DB2-BD59-A6C34878D82A}">
                    <a16:rowId xmlns:a16="http://schemas.microsoft.com/office/drawing/2014/main" val="1172611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54786162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760</Words>
  <Application>Microsoft Macintosh PowerPoint</Application>
  <PresentationFormat>Widescreen</PresentationFormat>
  <Paragraphs>2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Table S3: Patient demographics in 1st Line Cohor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5</cp:revision>
  <dcterms:created xsi:type="dcterms:W3CDTF">2022-06-12T16:24:02Z</dcterms:created>
  <dcterms:modified xsi:type="dcterms:W3CDTF">2022-06-27T19:53:46Z</dcterms:modified>
</cp:coreProperties>
</file>